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67" r:id="rId3"/>
    <p:sldId id="268" r:id="rId4"/>
    <p:sldId id="266" r:id="rId5"/>
  </p:sldIdLst>
  <p:sldSz cx="12192000" cy="6858000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1!$A$1:$A$8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cat>
          <c:val>
            <c:numRef>
              <c:f>Sheet1!$B$1:$B$8</c:f>
              <c:numCache>
                <c:formatCode>General</c:formatCode>
                <c:ptCount val="8"/>
                <c:pt idx="0">
                  <c:v>3</c:v>
                </c:pt>
                <c:pt idx="1">
                  <c:v>5</c:v>
                </c:pt>
                <c:pt idx="2">
                  <c:v>11</c:v>
                </c:pt>
                <c:pt idx="3">
                  <c:v>7</c:v>
                </c:pt>
                <c:pt idx="4">
                  <c:v>3</c:v>
                </c:pt>
                <c:pt idx="5">
                  <c:v>12</c:v>
                </c:pt>
                <c:pt idx="6">
                  <c:v>9</c:v>
                </c:pt>
                <c:pt idx="7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89-4E56-BA91-0AAAB99CE2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33087440"/>
        <c:axId val="1033090768"/>
      </c:barChart>
      <c:catAx>
        <c:axId val="103308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33090768"/>
        <c:crosses val="autoZero"/>
        <c:auto val="1"/>
        <c:lblAlgn val="ctr"/>
        <c:lblOffset val="100"/>
        <c:noMultiLvlLbl val="0"/>
      </c:catAx>
      <c:valAx>
        <c:axId val="1033090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3308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="1" i="0" baseline="0"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7E3E02-ACF3-430A-B9AA-D7016C1F30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E94380E-7B77-4A71-8E19-21ADD86214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610149-491B-45AD-8D0F-ADE4F1A00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A57E11-6583-4E11-A393-5AC62A754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944069B-2829-4FD1-9B03-2BFA95A1C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7001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85C91F-6D7F-4A69-9BFA-EA59482833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D6109B7-DDD5-496B-AC3B-E2B15AED68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0C7AEBB-94E9-4837-AE53-3AC2ABB1A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82B63B-204B-4DDE-B414-6C552A993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AB7DAF-3111-404E-8012-827CE050EB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3322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AD58381-6502-473E-8B2A-87DBB8609E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5CB825C-D817-4C4D-BBEA-606688DF07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906FB5-81FA-4334-A8C0-12EEAE475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9221A8-F78E-437E-8BE7-04F003CBD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FED9D2-F116-447B-86ED-DA42C2B9D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9702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24DBAC-0C85-4AC8-924F-0702BBDA4F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A147F1-6C28-4EDC-ACBC-990BCEC725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31613E-F612-4EB3-BA52-FE8090B45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E2D328-74AF-4923-8CE4-AD3C2D371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B57C1B-2328-46E5-B58A-FBEA1DAFA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7843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A19F19-A64F-4DA3-B3F3-57031B8BFD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7D50917-9719-4A62-ADC1-AA46FD8AF4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A551C4-62A6-48CA-B1DC-A56CF235E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2392EC-4CBF-4BDD-BE2C-2AEF939D8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59062C-9E88-49A4-B826-4876D7743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8747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1EED7B-CE6A-41E0-907E-26E15F12AE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9447586-6214-4678-949A-4FBF013C19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CDDAC65-8606-475B-8B81-173C10F7B5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C4CE748-44EE-49D8-B02C-ACA080AD0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CD464B1-1827-4608-8E9E-782301570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0E13D16-9DED-4030-A3F6-27889B376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319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82CB60-C7EA-44CA-B95A-6AA107EC9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36AF0B9-E705-455C-8960-4D82C2CEA8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B38E253-A071-4B59-B085-AA4DBBDE07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91B4445-5DA6-4E55-8098-851DC2D22D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0A33B9C-FE0A-4948-82F2-0E666D5BE6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3BB6E00-8988-4B7B-BC8C-8C243047F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BC687BD-77FC-4076-80F8-0AFDDEC02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0202563-E601-45D3-858A-DF1DC2E10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032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00306F-EB9A-4CAF-A80C-F062221E37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52EB7EA-F21A-40C1-B57B-B07D3D4ED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75B87E0-28E2-4600-A6C1-8CC8FB1C1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5076070-697A-4AF3-A3D0-45C34985A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22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6C44486-F48F-4B44-98D6-EB4497FDB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CDD26B2-A283-428B-BB69-020529A015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C62E2AF-528C-4707-8CED-A7B6B041E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286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56E37D-49FE-47B0-B003-9FC4D4BEBE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7B9207B-F7F3-4078-9096-E0BFAD1EC1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7A9B887-1256-4F99-B429-E135C3B729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1214433-D664-476C-B21A-13D54115D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73EDD9-8840-4F0A-8339-DFDE7103C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77B9CFF-2FB9-4DA8-8E61-4933D9645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278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B0CBF5-85E5-437D-893E-64EC25D95D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310575E-251C-47B3-8904-762B76540F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E54567C-F3C7-435F-8063-77E7F3C91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9FA33AC-171F-41E1-9536-B6D8BDC3B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60A1EFF-E62C-4744-83CA-567AC0386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19C7E74-9A4F-4C58-8D2B-90709893C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454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6EA39BF-3F31-45EA-9B86-2706F212D7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06FD552-B393-49D5-84F1-EDA96D4666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27B47A-C84D-42DD-83AF-8AA1A25AC1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73445D-E577-40B2-9D50-75685D329523}" type="datetimeFigureOut">
              <a:rPr kumimoji="1" lang="ja-JP" altLang="en-US" smtClean="0"/>
              <a:t>2021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A5244E-EF5A-46AA-A74F-C8A7241723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5535F1-E822-4C59-A29A-3860D7DFE1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FE49AD-6207-4263-9EDD-DC2E4CC635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0975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48640DAB-8572-4842-9288-2DC9EC69C6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2384" y="1595120"/>
            <a:ext cx="8777593" cy="344424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FEF96DF-6EE7-48C5-9787-CCD2AF5FA1FB}"/>
              </a:ext>
            </a:extLst>
          </p:cNvPr>
          <p:cNvSpPr txBox="1"/>
          <p:nvPr/>
        </p:nvSpPr>
        <p:spPr>
          <a:xfrm>
            <a:off x="2043161" y="579457"/>
            <a:ext cx="753603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Table </a:t>
            </a:r>
            <a:r>
              <a:rPr lang="en-US" altLang="ja-JP" b="1" dirty="0"/>
              <a:t>S</a:t>
            </a:r>
            <a:r>
              <a:rPr kumimoji="1" lang="en-US" altLang="ja-JP" b="1" dirty="0"/>
              <a:t>1.</a:t>
            </a:r>
            <a:r>
              <a:rPr lang="ja-JP" altLang="en-US" b="1" dirty="0"/>
              <a:t>  </a:t>
            </a:r>
            <a:r>
              <a:rPr lang="en-US" altLang="ja-JP" b="1" dirty="0"/>
              <a:t>Numbers</a:t>
            </a:r>
            <a:r>
              <a:rPr lang="ja-JP" altLang="en-US" b="1" dirty="0"/>
              <a:t> </a:t>
            </a:r>
            <a:r>
              <a:rPr lang="en-US" altLang="ja-JP" b="1" dirty="0"/>
              <a:t>of</a:t>
            </a:r>
            <a:r>
              <a:rPr lang="ja-JP" altLang="en-US" b="1" dirty="0"/>
              <a:t> </a:t>
            </a:r>
            <a:r>
              <a:rPr lang="en-US" altLang="ja-JP" b="1" dirty="0"/>
              <a:t>patients</a:t>
            </a:r>
            <a:r>
              <a:rPr lang="ja-JP" altLang="en-US" b="1" dirty="0"/>
              <a:t> </a:t>
            </a:r>
            <a:r>
              <a:rPr lang="en-US" altLang="ja-JP" b="1" dirty="0"/>
              <a:t>with high-risk factors</a:t>
            </a:r>
            <a:r>
              <a:rPr lang="ja-JP" altLang="en-US" b="1" dirty="0"/>
              <a:t> </a:t>
            </a:r>
            <a:endParaRPr lang="en-US" altLang="ja-JP" b="1" dirty="0"/>
          </a:p>
          <a:p>
            <a:r>
              <a:rPr lang="en-US" altLang="ja-JP" b="1" dirty="0"/>
              <a:t>                  in</a:t>
            </a:r>
            <a:r>
              <a:rPr lang="ja-JP" altLang="en-US" b="1" dirty="0"/>
              <a:t> </a:t>
            </a:r>
            <a:r>
              <a:rPr lang="en-US" altLang="ja-JP" b="1" dirty="0" err="1"/>
              <a:t>ronapreve</a:t>
            </a:r>
            <a:r>
              <a:rPr lang="ja-JP" altLang="en-US" b="1" dirty="0"/>
              <a:t> </a:t>
            </a:r>
            <a:r>
              <a:rPr lang="en-US" altLang="ja-JP" b="1" dirty="0"/>
              <a:t>and</a:t>
            </a:r>
            <a:r>
              <a:rPr lang="ja-JP" altLang="en-US" b="1" dirty="0"/>
              <a:t> </a:t>
            </a:r>
            <a:r>
              <a:rPr lang="en-US" altLang="ja-JP" b="1" dirty="0"/>
              <a:t>watchful</a:t>
            </a:r>
            <a:r>
              <a:rPr lang="ja-JP" altLang="en-US" b="1" dirty="0"/>
              <a:t> </a:t>
            </a:r>
            <a:r>
              <a:rPr lang="en-US" altLang="ja-JP" b="1" dirty="0"/>
              <a:t>observation</a:t>
            </a:r>
            <a:r>
              <a:rPr lang="ja-JP" altLang="en-US" b="1" dirty="0"/>
              <a:t> </a:t>
            </a:r>
            <a:r>
              <a:rPr lang="en-US" altLang="ja-JP" b="1" dirty="0"/>
              <a:t>groups</a:t>
            </a:r>
            <a:r>
              <a:rPr lang="ja-JP" altLang="en-US" b="1" dirty="0"/>
              <a:t> </a:t>
            </a:r>
            <a:r>
              <a:rPr lang="en-US" altLang="ja-JP" b="1" dirty="0"/>
              <a:t>together</a:t>
            </a:r>
            <a:endParaRPr kumimoji="1" lang="ja-JP" altLang="en-US" b="1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768729F-1AC0-4653-B183-BA35D359C8EC}"/>
              </a:ext>
            </a:extLst>
          </p:cNvPr>
          <p:cNvSpPr txBox="1"/>
          <p:nvPr/>
        </p:nvSpPr>
        <p:spPr>
          <a:xfrm>
            <a:off x="1932788" y="5262880"/>
            <a:ext cx="5884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A patient is counted to be overlapped if applicable.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7490577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200D4A89-39BD-4FA6-8746-3FE1ACABA4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8684" y="2647315"/>
            <a:ext cx="10531429" cy="156337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F550235-F42C-4788-95BF-A120FAD85C2A}"/>
              </a:ext>
            </a:extLst>
          </p:cNvPr>
          <p:cNvSpPr txBox="1"/>
          <p:nvPr/>
        </p:nvSpPr>
        <p:spPr>
          <a:xfrm>
            <a:off x="789788" y="1567815"/>
            <a:ext cx="9688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Table </a:t>
            </a:r>
            <a:r>
              <a:rPr lang="en-US" altLang="ja-JP" b="1" dirty="0"/>
              <a:t>S2</a:t>
            </a:r>
            <a:r>
              <a:rPr kumimoji="1" lang="en-US" altLang="ja-JP" b="1" dirty="0"/>
              <a:t>.  </a:t>
            </a:r>
            <a:r>
              <a:rPr lang="en-US" altLang="ja-JP" b="1" dirty="0"/>
              <a:t>Fever-relief after </a:t>
            </a:r>
            <a:r>
              <a:rPr lang="en-US" altLang="ja-JP" b="1" dirty="0" err="1"/>
              <a:t>ronapreve</a:t>
            </a:r>
            <a:r>
              <a:rPr lang="en-US" altLang="ja-JP" b="1" dirty="0"/>
              <a:t> administration in vaccinated patients enrolled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29561200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08BEE8D-30BC-4ADA-AF9E-36C5F0E41290}"/>
              </a:ext>
            </a:extLst>
          </p:cNvPr>
          <p:cNvSpPr txBox="1"/>
          <p:nvPr/>
        </p:nvSpPr>
        <p:spPr>
          <a:xfrm>
            <a:off x="580238" y="1358265"/>
            <a:ext cx="5266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Table </a:t>
            </a:r>
            <a:r>
              <a:rPr lang="en-US" altLang="ja-JP" b="1" dirty="0"/>
              <a:t>S3</a:t>
            </a:r>
            <a:r>
              <a:rPr kumimoji="1" lang="en-US" altLang="ja-JP" b="1" dirty="0"/>
              <a:t>.  Adverse events in </a:t>
            </a:r>
            <a:r>
              <a:rPr kumimoji="1" lang="en-US" altLang="ja-JP" b="1" dirty="0" err="1"/>
              <a:t>ronapreve</a:t>
            </a:r>
            <a:r>
              <a:rPr kumimoji="1" lang="en-US" altLang="ja-JP" b="1" dirty="0"/>
              <a:t> group</a:t>
            </a:r>
            <a:endParaRPr kumimoji="1" lang="ja-JP" altLang="en-US" b="1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118B8410-0948-43D0-9FB0-B913E4252B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8198" y="2371963"/>
            <a:ext cx="10415604" cy="13754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13534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57E5D1F6-44B9-4FC1-B56A-037D5FA735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1812947"/>
              </p:ext>
            </p:extLst>
          </p:nvPr>
        </p:nvGraphicFramePr>
        <p:xfrm>
          <a:off x="2552700" y="1438275"/>
          <a:ext cx="6019800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33BEB80-AC58-4AC7-9F6A-51351678BFD4}"/>
              </a:ext>
            </a:extLst>
          </p:cNvPr>
          <p:cNvSpPr txBox="1"/>
          <p:nvPr/>
        </p:nvSpPr>
        <p:spPr>
          <a:xfrm>
            <a:off x="688780" y="425990"/>
            <a:ext cx="7603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igure S1.  Timing of </a:t>
            </a:r>
            <a:r>
              <a:rPr kumimoji="1" lang="en-US" altLang="ja-JP" b="1" dirty="0" err="1"/>
              <a:t>ronapreve</a:t>
            </a:r>
            <a:r>
              <a:rPr kumimoji="1" lang="en-US" altLang="ja-JP" b="1" dirty="0"/>
              <a:t> administration from disease onset</a:t>
            </a:r>
            <a:endParaRPr kumimoji="1" lang="ja-JP" altLang="en-US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766566B-5F38-4154-B519-229D8A47C78D}"/>
              </a:ext>
            </a:extLst>
          </p:cNvPr>
          <p:cNvSpPr txBox="1"/>
          <p:nvPr/>
        </p:nvSpPr>
        <p:spPr>
          <a:xfrm>
            <a:off x="3193250" y="4867275"/>
            <a:ext cx="6202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Days </a:t>
            </a:r>
            <a:r>
              <a:rPr lang="en-US" altLang="ja-JP" b="1" dirty="0"/>
              <a:t>of </a:t>
            </a:r>
            <a:r>
              <a:rPr kumimoji="1" lang="en-US" altLang="ja-JP" b="1" dirty="0" err="1"/>
              <a:t>Ronapreve</a:t>
            </a:r>
            <a:r>
              <a:rPr kumimoji="1" lang="en-US" altLang="ja-JP" b="1" dirty="0"/>
              <a:t> administration from </a:t>
            </a:r>
            <a:r>
              <a:rPr lang="en-US" altLang="ja-JP" b="1" dirty="0"/>
              <a:t>disease </a:t>
            </a:r>
            <a:r>
              <a:rPr kumimoji="1" lang="en-US" altLang="ja-JP" b="1" dirty="0"/>
              <a:t>onset</a:t>
            </a:r>
            <a:endParaRPr kumimoji="1" lang="ja-JP" altLang="en-US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08AB9EB-28C1-4C17-BF8E-9A19F95D79A2}"/>
              </a:ext>
            </a:extLst>
          </p:cNvPr>
          <p:cNvSpPr txBox="1"/>
          <p:nvPr/>
        </p:nvSpPr>
        <p:spPr>
          <a:xfrm>
            <a:off x="2449776" y="1068943"/>
            <a:ext cx="513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(n)</a:t>
            </a:r>
            <a:endParaRPr kumimoji="1" lang="ja-JP" altLang="en-US" b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FA75CDA-651C-4798-9826-10F058A9D28E}"/>
              </a:ext>
            </a:extLst>
          </p:cNvPr>
          <p:cNvSpPr txBox="1"/>
          <p:nvPr/>
        </p:nvSpPr>
        <p:spPr>
          <a:xfrm rot="16200000">
            <a:off x="418926" y="2678999"/>
            <a:ext cx="35894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No. of patients with </a:t>
            </a:r>
            <a:r>
              <a:rPr lang="en-US" altLang="ja-JP" b="1" dirty="0" err="1"/>
              <a:t>ronapreve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1534036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5</TotalTime>
  <Words>72</Words>
  <Application>Microsoft Office PowerPoint</Application>
  <PresentationFormat>ワイド画面</PresentationFormat>
  <Paragraphs>9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kinoki yasutaka</dc:creator>
  <cp:lastModifiedBy>kakinoki yasutaka</cp:lastModifiedBy>
  <cp:revision>59</cp:revision>
  <cp:lastPrinted>2021-09-26T02:11:25Z</cp:lastPrinted>
  <dcterms:created xsi:type="dcterms:W3CDTF">2021-09-22T08:25:42Z</dcterms:created>
  <dcterms:modified xsi:type="dcterms:W3CDTF">2021-10-08T01:42:55Z</dcterms:modified>
</cp:coreProperties>
</file>